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270" autoAdjust="0"/>
  </p:normalViewPr>
  <p:slideViewPr>
    <p:cSldViewPr snapToGrid="0">
      <p:cViewPr varScale="1">
        <p:scale>
          <a:sx n="81" d="100"/>
          <a:sy n="81" d="100"/>
        </p:scale>
        <p:origin x="23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42978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9914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315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4404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5689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1177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600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341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8688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548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4524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17D52-4170-49C1-85A7-5061E761A3FF}" type="datetimeFigureOut">
              <a:rPr kumimoji="1" lang="ja-JP" altLang="en-US" smtClean="0"/>
              <a:t>2020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11270A-70C0-411E-B8FC-4668EBC41B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0100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図 8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8847" y="1035426"/>
            <a:ext cx="972634" cy="3775485"/>
          </a:xfrm>
          <a:prstGeom prst="rect">
            <a:avLst/>
          </a:prstGeom>
        </p:spPr>
      </p:pic>
      <p:pic>
        <p:nvPicPr>
          <p:cNvPr id="96" name="図 9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62004" y="1030662"/>
            <a:ext cx="918384" cy="3780249"/>
          </a:xfrm>
          <a:prstGeom prst="rect">
            <a:avLst/>
          </a:prstGeom>
        </p:spPr>
      </p:pic>
      <p:pic>
        <p:nvPicPr>
          <p:cNvPr id="97" name="図 9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348429" y="1030058"/>
            <a:ext cx="911695" cy="3780853"/>
          </a:xfrm>
          <a:prstGeom prst="rect">
            <a:avLst/>
          </a:prstGeom>
        </p:spPr>
      </p:pic>
      <p:pic>
        <p:nvPicPr>
          <p:cNvPr id="102" name="図 10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99920" y="1029076"/>
            <a:ext cx="894974" cy="3786824"/>
          </a:xfrm>
          <a:prstGeom prst="rect">
            <a:avLst/>
          </a:prstGeom>
        </p:spPr>
      </p:pic>
      <p:pic>
        <p:nvPicPr>
          <p:cNvPr id="103" name="図 10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683994" y="1033643"/>
            <a:ext cx="921288" cy="3765367"/>
          </a:xfrm>
          <a:prstGeom prst="rect">
            <a:avLst/>
          </a:prstGeom>
        </p:spPr>
      </p:pic>
      <p:pic>
        <p:nvPicPr>
          <p:cNvPr id="104" name="図 10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789813" y="1031862"/>
            <a:ext cx="923441" cy="3779050"/>
          </a:xfrm>
          <a:prstGeom prst="rect">
            <a:avLst/>
          </a:prstGeom>
        </p:spPr>
      </p:pic>
      <p:pic>
        <p:nvPicPr>
          <p:cNvPr id="59" name="図 5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103" b="2347"/>
          <a:stretch/>
        </p:blipFill>
        <p:spPr>
          <a:xfrm>
            <a:off x="1195301" y="7045946"/>
            <a:ext cx="5298444" cy="1598796"/>
          </a:xfrm>
          <a:prstGeom prst="rect">
            <a:avLst/>
          </a:prstGeom>
        </p:spPr>
      </p:pic>
      <p:sp>
        <p:nvSpPr>
          <p:cNvPr id="2" name="Text Box 6"/>
          <p:cNvSpPr txBox="1">
            <a:spLocks noChangeArrowheads="1"/>
          </p:cNvSpPr>
          <p:nvPr/>
        </p:nvSpPr>
        <p:spPr bwMode="auto">
          <a:xfrm>
            <a:off x="10402" y="12024"/>
            <a:ext cx="324972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ja-JP" b="1" dirty="0" smtClean="0"/>
              <a:t>Figure</a:t>
            </a:r>
            <a:r>
              <a:rPr lang="ja-JP" altLang="en-US" b="1" dirty="0" smtClean="0"/>
              <a:t> </a:t>
            </a:r>
            <a:r>
              <a:rPr lang="en-US" altLang="ja-JP" b="1" dirty="0" smtClean="0"/>
              <a:t>S3</a:t>
            </a:r>
            <a:endParaRPr lang="en-US" altLang="ja-JP" b="1" dirty="0"/>
          </a:p>
        </p:txBody>
      </p:sp>
      <p:pic>
        <p:nvPicPr>
          <p:cNvPr id="14" name="図 1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09965" y="5136487"/>
            <a:ext cx="5272668" cy="1601071"/>
          </a:xfrm>
          <a:prstGeom prst="rect">
            <a:avLst/>
          </a:prstGeom>
        </p:spPr>
      </p:pic>
      <p:sp>
        <p:nvSpPr>
          <p:cNvPr id="24" name="テキスト ボックス 23"/>
          <p:cNvSpPr txBox="1"/>
          <p:nvPr/>
        </p:nvSpPr>
        <p:spPr>
          <a:xfrm>
            <a:off x="3435907" y="8726273"/>
            <a:ext cx="9044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357083" y="858785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735702" y="858786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176251" y="858785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464373" y="858785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802500" y="858785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150165" y="858786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459756" y="858785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724076" y="858785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997938" y="858785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4209852" y="858785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483688" y="858785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4695618" y="858785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4971852" y="858785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5179023" y="85878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5357637" y="868785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531472" y="85878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693412" y="868785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5833890" y="85878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962464" y="868785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6088671" y="85878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6186304" y="868785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6293463" y="858785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047625" y="556888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965075" y="5251382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933325" y="5873682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0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933325" y="6191182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0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933325" y="6502332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047625" y="747675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965075" y="7146555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933325" y="7775205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0.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933325" y="8092705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0.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933325" y="8403855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1.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 rot="16200000">
            <a:off x="224089" y="6769628"/>
            <a:ext cx="13227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g2</a:t>
            </a:r>
            <a:r>
              <a:rPr lang="ja-JP" alt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py</a:t>
            </a:r>
            <a:r>
              <a:rPr lang="ja-JP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ja-JP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ti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151105" y="5543025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</a:t>
            </a:r>
            <a:r>
              <a:rPr kumimoji="1" lang="ja-JP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en-US" altLang="ja-JP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148189" y="7464723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e</a:t>
            </a:r>
            <a:r>
              <a:rPr kumimoji="1" lang="ja-JP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en-US" altLang="ja-JP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19416" y="5132809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17438" y="349296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205447" y="784728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1296072" y="784720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2400971" y="784714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3601131" y="784706"/>
            <a:ext cx="990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/>
          <p:cNvSpPr txBox="1"/>
          <p:nvPr/>
        </p:nvSpPr>
        <p:spPr>
          <a:xfrm>
            <a:off x="4720318" y="784702"/>
            <a:ext cx="990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5815699" y="784694"/>
            <a:ext cx="990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1357083" y="668158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1735702" y="668159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2176251" y="66815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2464373" y="66815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2802500" y="668158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3150165" y="668159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3459756" y="66815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3724076" y="668158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/>
          <p:cNvSpPr txBox="1"/>
          <p:nvPr/>
        </p:nvSpPr>
        <p:spPr>
          <a:xfrm>
            <a:off x="3997938" y="668158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4209852" y="66815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4483688" y="668158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4695618" y="668158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4971852" y="668158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5179023" y="668159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5357637" y="67815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5531472" y="668158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5693412" y="67815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5833890" y="668158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5962464" y="678158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/>
          <p:cNvSpPr txBox="1"/>
          <p:nvPr/>
        </p:nvSpPr>
        <p:spPr>
          <a:xfrm>
            <a:off x="6088671" y="668158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6186304" y="678158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/>
          <p:cNvSpPr txBox="1"/>
          <p:nvPr/>
        </p:nvSpPr>
        <p:spPr>
          <a:xfrm>
            <a:off x="6293463" y="668158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7564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1</TotalTime>
  <Words>85</Words>
  <Application>Microsoft Office PowerPoint</Application>
  <PresentationFormat>画面に合わせる (4:3)</PresentationFormat>
  <Paragraphs>6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busawa</dc:creator>
  <cp:lastModifiedBy>nobusawa</cp:lastModifiedBy>
  <cp:revision>26</cp:revision>
  <cp:lastPrinted>2020-06-26T07:57:29Z</cp:lastPrinted>
  <dcterms:created xsi:type="dcterms:W3CDTF">2020-06-26T06:43:28Z</dcterms:created>
  <dcterms:modified xsi:type="dcterms:W3CDTF">2020-10-09T10:18:52Z</dcterms:modified>
</cp:coreProperties>
</file>